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2"/>
    <p:sldId id="256" r:id="rId3"/>
    <p:sldId id="261" r:id="rId4"/>
    <p:sldId id="263" r:id="rId5"/>
    <p:sldId id="257" r:id="rId6"/>
    <p:sldId id="260" r:id="rId7"/>
  </p:sldIdLst>
  <p:sldSz cx="12192000" cy="6858000"/>
  <p:notesSz cx="7772400" cy="10058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 snapToObjects="1">
      <p:cViewPr varScale="1">
        <p:scale>
          <a:sx n="93" d="100"/>
          <a:sy n="93" d="100"/>
        </p:scale>
        <p:origin x="1152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x Feltus" userId="7e0966e74e74eb59" providerId="LiveId" clId="{9FC03E93-FA20-4D82-9591-C33D3B48B1F9}"/>
    <pc:docChg chg="custSel addSld modSld">
      <pc:chgData name="Alex Feltus" userId="7e0966e74e74eb59" providerId="LiveId" clId="{9FC03E93-FA20-4D82-9591-C33D3B48B1F9}" dt="2025-01-14T19:16:16.717" v="221" actId="1076"/>
      <pc:docMkLst>
        <pc:docMk/>
      </pc:docMkLst>
      <pc:sldChg chg="addSp delSp modSp mod">
        <pc:chgData name="Alex Feltus" userId="7e0966e74e74eb59" providerId="LiveId" clId="{9FC03E93-FA20-4D82-9591-C33D3B48B1F9}" dt="2025-01-14T19:13:09.558" v="4" actId="478"/>
        <pc:sldMkLst>
          <pc:docMk/>
          <pc:sldMk cId="0" sldId="257"/>
        </pc:sldMkLst>
      </pc:sldChg>
      <pc:sldChg chg="addSp delSp modSp add mod">
        <pc:chgData name="Alex Feltus" userId="7e0966e74e74eb59" providerId="LiveId" clId="{9FC03E93-FA20-4D82-9591-C33D3B48B1F9}" dt="2025-01-14T19:16:16.717" v="221" actId="1076"/>
        <pc:sldMkLst>
          <pc:docMk/>
          <pc:sldMk cId="3877186025" sldId="260"/>
        </pc:sldMkLst>
        <pc:spChg chg="add mod">
          <ac:chgData name="Alex Feltus" userId="7e0966e74e74eb59" providerId="LiveId" clId="{9FC03E93-FA20-4D82-9591-C33D3B48B1F9}" dt="2025-01-14T19:16:09.046" v="218" actId="313"/>
          <ac:spMkLst>
            <pc:docMk/>
            <pc:sldMk cId="3877186025" sldId="260"/>
            <ac:spMk id="4" creationId="{1BEBAA8D-606A-4CCE-AFFB-16A4A24A4E08}"/>
          </ac:spMkLst>
        </pc:spChg>
        <pc:spChg chg="mod">
          <ac:chgData name="Alex Feltus" userId="7e0966e74e74eb59" providerId="LiveId" clId="{9FC03E93-FA20-4D82-9591-C33D3B48B1F9}" dt="2025-01-14T19:16:16.717" v="221" actId="1076"/>
          <ac:spMkLst>
            <pc:docMk/>
            <pc:sldMk cId="3877186025" sldId="260"/>
            <ac:spMk id="40" creationId="{967E3B2A-094E-06DD-E9C2-330C0FE5080F}"/>
          </ac:spMkLst>
        </pc:spChg>
        <pc:picChg chg="mod modCrop">
          <ac:chgData name="Alex Feltus" userId="7e0966e74e74eb59" providerId="LiveId" clId="{9FC03E93-FA20-4D82-9591-C33D3B48B1F9}" dt="2025-01-14T19:14:54.417" v="79" actId="1076"/>
          <ac:picMkLst>
            <pc:docMk/>
            <pc:sldMk cId="3877186025" sldId="260"/>
            <ac:picMk id="3" creationId="{9F56F1F8-B727-219F-1304-DD3F060A1C83}"/>
          </ac:picMkLst>
        </pc:picChg>
      </pc:sldChg>
    </pc:docChg>
  </pc:docChgLst>
  <pc:docChgLst>
    <pc:chgData name="Alex Feltus" userId="7e0966e74e74eb59" providerId="LiveId" clId="{45E5946A-7B27-40A3-83A0-964650D61833}"/>
    <pc:docChg chg="modSld">
      <pc:chgData name="Alex Feltus" userId="7e0966e74e74eb59" providerId="LiveId" clId="{45E5946A-7B27-40A3-83A0-964650D61833}" dt="2025-01-17T20:20:26.730" v="5" actId="20577"/>
      <pc:docMkLst>
        <pc:docMk/>
      </pc:docMkLst>
      <pc:sldChg chg="modSp mod">
        <pc:chgData name="Alex Feltus" userId="7e0966e74e74eb59" providerId="LiveId" clId="{45E5946A-7B27-40A3-83A0-964650D61833}" dt="2025-01-17T20:20:16.321" v="1" actId="20577"/>
        <pc:sldMkLst>
          <pc:docMk/>
          <pc:sldMk cId="0" sldId="256"/>
        </pc:sldMkLst>
        <pc:spChg chg="mod">
          <ac:chgData name="Alex Feltus" userId="7e0966e74e74eb59" providerId="LiveId" clId="{45E5946A-7B27-40A3-83A0-964650D61833}" dt="2025-01-17T20:20:16.321" v="1" actId="20577"/>
          <ac:spMkLst>
            <pc:docMk/>
            <pc:sldMk cId="0" sldId="256"/>
            <ac:spMk id="38" creationId="{00000000-0000-0000-0000-000000000000}"/>
          </ac:spMkLst>
        </pc:spChg>
      </pc:sldChg>
      <pc:sldChg chg="modSp mod">
        <pc:chgData name="Alex Feltus" userId="7e0966e74e74eb59" providerId="LiveId" clId="{45E5946A-7B27-40A3-83A0-964650D61833}" dt="2025-01-17T20:20:23.558" v="4" actId="20577"/>
        <pc:sldMkLst>
          <pc:docMk/>
          <pc:sldMk cId="0" sldId="257"/>
        </pc:sldMkLst>
        <pc:spChg chg="mod">
          <ac:chgData name="Alex Feltus" userId="7e0966e74e74eb59" providerId="LiveId" clId="{45E5946A-7B27-40A3-83A0-964650D61833}" dt="2025-01-17T20:20:23.558" v="4" actId="20577"/>
          <ac:spMkLst>
            <pc:docMk/>
            <pc:sldMk cId="0" sldId="257"/>
            <ac:spMk id="40" creationId="{00000000-0000-0000-0000-000000000000}"/>
          </ac:spMkLst>
        </pc:spChg>
      </pc:sldChg>
      <pc:sldChg chg="modSp mod">
        <pc:chgData name="Alex Feltus" userId="7e0966e74e74eb59" providerId="LiveId" clId="{45E5946A-7B27-40A3-83A0-964650D61833}" dt="2025-01-17T20:20:11.038" v="0" actId="20577"/>
        <pc:sldMkLst>
          <pc:docMk/>
          <pc:sldMk cId="2153507489" sldId="259"/>
        </pc:sldMkLst>
        <pc:spChg chg="mod">
          <ac:chgData name="Alex Feltus" userId="7e0966e74e74eb59" providerId="LiveId" clId="{45E5946A-7B27-40A3-83A0-964650D61833}" dt="2025-01-17T20:20:11.038" v="0" actId="20577"/>
          <ac:spMkLst>
            <pc:docMk/>
            <pc:sldMk cId="2153507489" sldId="259"/>
            <ac:spMk id="38" creationId="{00000000-0000-0000-0000-000000000000}"/>
          </ac:spMkLst>
        </pc:spChg>
      </pc:sldChg>
      <pc:sldChg chg="modSp mod">
        <pc:chgData name="Alex Feltus" userId="7e0966e74e74eb59" providerId="LiveId" clId="{45E5946A-7B27-40A3-83A0-964650D61833}" dt="2025-01-17T20:20:26.730" v="5" actId="20577"/>
        <pc:sldMkLst>
          <pc:docMk/>
          <pc:sldMk cId="3877186025" sldId="260"/>
        </pc:sldMkLst>
        <pc:spChg chg="mod">
          <ac:chgData name="Alex Feltus" userId="7e0966e74e74eb59" providerId="LiveId" clId="{45E5946A-7B27-40A3-83A0-964650D61833}" dt="2025-01-17T20:20:26.730" v="5" actId="20577"/>
          <ac:spMkLst>
            <pc:docMk/>
            <pc:sldMk cId="3877186025" sldId="260"/>
            <ac:spMk id="40" creationId="{967E3B2A-094E-06DD-E9C2-330C0FE5080F}"/>
          </ac:spMkLst>
        </pc:spChg>
      </pc:sldChg>
      <pc:sldChg chg="modSp mod">
        <pc:chgData name="Alex Feltus" userId="7e0966e74e74eb59" providerId="LiveId" clId="{45E5946A-7B27-40A3-83A0-964650D61833}" dt="2025-01-17T20:20:18.781" v="2" actId="20577"/>
        <pc:sldMkLst>
          <pc:docMk/>
          <pc:sldMk cId="3354475510" sldId="261"/>
        </pc:sldMkLst>
        <pc:spChg chg="mod">
          <ac:chgData name="Alex Feltus" userId="7e0966e74e74eb59" providerId="LiveId" clId="{45E5946A-7B27-40A3-83A0-964650D61833}" dt="2025-01-17T20:20:18.781" v="2" actId="20577"/>
          <ac:spMkLst>
            <pc:docMk/>
            <pc:sldMk cId="3354475510" sldId="261"/>
            <ac:spMk id="38" creationId="{00000000-0000-0000-0000-000000000000}"/>
          </ac:spMkLst>
        </pc:spChg>
      </pc:sldChg>
      <pc:sldChg chg="modSp mod">
        <pc:chgData name="Alex Feltus" userId="7e0966e74e74eb59" providerId="LiveId" clId="{45E5946A-7B27-40A3-83A0-964650D61833}" dt="2025-01-17T20:20:21.170" v="3" actId="20577"/>
        <pc:sldMkLst>
          <pc:docMk/>
          <pc:sldMk cId="78292283" sldId="263"/>
        </pc:sldMkLst>
        <pc:spChg chg="mod">
          <ac:chgData name="Alex Feltus" userId="7e0966e74e74eb59" providerId="LiveId" clId="{45E5946A-7B27-40A3-83A0-964650D61833}" dt="2025-01-17T20:20:21.170" v="3" actId="20577"/>
          <ac:spMkLst>
            <pc:docMk/>
            <pc:sldMk cId="78292283" sldId="263"/>
            <ac:spMk id="38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0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0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35326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4319280" y="1604520"/>
            <a:ext cx="35326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8028720" y="1604520"/>
            <a:ext cx="35326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609480" y="3682080"/>
            <a:ext cx="35326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4319280" y="3682080"/>
            <a:ext cx="35326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8028720" y="3682080"/>
            <a:ext cx="35326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080" cy="39769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080" cy="3976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6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6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1523880" y="1122480"/>
            <a:ext cx="9142920" cy="11063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6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6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0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en-US" sz="18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080" cy="39769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8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8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8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8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8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800" b="0" strike="noStrike" spc="-1"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stomShape 1"/>
          <p:cNvSpPr/>
          <p:nvPr/>
        </p:nvSpPr>
        <p:spPr>
          <a:xfrm>
            <a:off x="1361363" y="4899834"/>
            <a:ext cx="9469274" cy="644877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Supplemental Figure S1. </a:t>
            </a:r>
            <a:r>
              <a:rPr lang="en-US" spc="-1" dirty="0">
                <a:solidFill>
                  <a:srgbClr val="000000"/>
                </a:solidFill>
              </a:rPr>
              <a:t>Diffusion gene perturbation with Mitotic Spindle Subset – non balance samples plot 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5" name="Picture 4" descr="A diagram of a cancer tumor&#10;&#10;Description automatically generated with medium confidence">
            <a:extLst>
              <a:ext uri="{FF2B5EF4-FFF2-40B4-BE49-F238E27FC236}">
                <a16:creationId xmlns:a16="http://schemas.microsoft.com/office/drawing/2014/main" id="{8D034A42-9C2D-EA44-AD7C-770D8F9791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5350" y="1059592"/>
            <a:ext cx="10401300" cy="342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35074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stomShape 1"/>
          <p:cNvSpPr/>
          <p:nvPr/>
        </p:nvSpPr>
        <p:spPr>
          <a:xfrm>
            <a:off x="2590920" y="5299560"/>
            <a:ext cx="6094800" cy="1475873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Supplemental Figure S2. </a:t>
            </a:r>
            <a:r>
              <a:rPr lang="en-US" sz="18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UMAP parameter sweep covered a range of n\_neighbors from 15 to 180, and a range of min\_</a:t>
            </a:r>
            <a:r>
              <a:rPr lang="en-US" sz="18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dist</a:t>
            </a:r>
            <a:r>
              <a:rPr lang="en-US" sz="18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from 0.0 to 0.9. It is one of experiments with 16 gene features randomly selected from 19,738 genes</a:t>
            </a:r>
            <a:r>
              <a:rPr lang="en-US" sz="18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.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39" name="Picture 38"/>
          <p:cNvPicPr/>
          <p:nvPr/>
        </p:nvPicPr>
        <p:blipFill>
          <a:blip r:embed="rId2"/>
          <a:stretch/>
        </p:blipFill>
        <p:spPr>
          <a:xfrm>
            <a:off x="2743200" y="91440"/>
            <a:ext cx="5236560" cy="527148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stomShape 1"/>
          <p:cNvSpPr/>
          <p:nvPr/>
        </p:nvSpPr>
        <p:spPr>
          <a:xfrm>
            <a:off x="2590920" y="5299560"/>
            <a:ext cx="6094800" cy="921876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Supplemental Figure S3. </a:t>
            </a:r>
            <a:r>
              <a:rPr lang="en-US" spc="-1" dirty="0" err="1">
                <a:solidFill>
                  <a:srgbClr val="000000"/>
                </a:solidFill>
              </a:rPr>
              <a:t>GEMDiff</a:t>
            </a:r>
            <a:r>
              <a:rPr lang="en-US" spc="-1" dirty="0">
                <a:solidFill>
                  <a:srgbClr val="000000"/>
                </a:solidFill>
              </a:rPr>
              <a:t> (50%) gene augmentation with varying ranges of gene features from 8 to 256, visualized by UMAP plots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3" name="Picture 2" descr="A group of images of different colored dots&#10;&#10;Description automatically generated">
            <a:extLst>
              <a:ext uri="{FF2B5EF4-FFF2-40B4-BE49-F238E27FC236}">
                <a16:creationId xmlns:a16="http://schemas.microsoft.com/office/drawing/2014/main" id="{41D964AC-9389-A24D-A4C6-59285FC46B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9446" y="197708"/>
            <a:ext cx="9133108" cy="51018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44755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stomShape 1"/>
          <p:cNvSpPr/>
          <p:nvPr/>
        </p:nvSpPr>
        <p:spPr>
          <a:xfrm>
            <a:off x="2590920" y="5299560"/>
            <a:ext cx="6094800" cy="921876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Supplemental Figure S4. </a:t>
            </a:r>
            <a:r>
              <a:rPr lang="en-US" spc="-1" dirty="0" err="1">
                <a:solidFill>
                  <a:srgbClr val="000000"/>
                </a:solidFill>
              </a:rPr>
              <a:t>GEMDiff</a:t>
            </a:r>
            <a:r>
              <a:rPr lang="en-US" spc="-1" dirty="0">
                <a:solidFill>
                  <a:srgbClr val="000000"/>
                </a:solidFill>
              </a:rPr>
              <a:t> (30%) gene augmentation with varying ranges of gene features from 8 to 256, visualized by UMAP plots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4" name="Picture 3" descr="A group of images of different colored dots&#10;&#10;Description automatically generated">
            <a:extLst>
              <a:ext uri="{FF2B5EF4-FFF2-40B4-BE49-F238E27FC236}">
                <a16:creationId xmlns:a16="http://schemas.microsoft.com/office/drawing/2014/main" id="{9D21F6F9-F78A-1746-AC79-D231A462E3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3920" y="209452"/>
            <a:ext cx="8504160" cy="489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2922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CustomShape 1"/>
          <p:cNvSpPr/>
          <p:nvPr/>
        </p:nvSpPr>
        <p:spPr>
          <a:xfrm>
            <a:off x="2590920" y="5299560"/>
            <a:ext cx="6094800" cy="921876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Supplemental Figure S5. </a:t>
            </a:r>
            <a:r>
              <a:rPr lang="en-US" sz="18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Histogram of silhouette score experiments.</a:t>
            </a:r>
            <a:r>
              <a:rPr lang="en-US" sz="1800" b="0" strike="noStrike" spc="-1" dirty="0">
                <a:solidFill>
                  <a:srgbClr val="000000"/>
                </a:solidFill>
                <a:latin typeface="Aptos"/>
                <a:ea typeface="DejaVu Sans"/>
              </a:rPr>
              <a:t> All = select gene from</a:t>
            </a:r>
            <a:r>
              <a:rPr lang="en-US" sz="18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ll 19,738 genes</a:t>
            </a:r>
            <a:r>
              <a:rPr lang="en-US" sz="1800" b="0" strike="noStrike" spc="-1" dirty="0">
                <a:solidFill>
                  <a:srgbClr val="000000"/>
                </a:solidFill>
                <a:latin typeface="Aptos"/>
                <a:ea typeface="DejaVu Sans"/>
              </a:rPr>
              <a:t> randomly. Hm = select gene from</a:t>
            </a:r>
            <a:r>
              <a:rPr lang="en-US" sz="18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Hallmark sets randomly</a:t>
            </a:r>
            <a:r>
              <a:rPr lang="en-US" sz="1800" b="0" strike="noStrike" spc="-1" dirty="0">
                <a:solidFill>
                  <a:srgbClr val="000000"/>
                </a:solidFill>
                <a:latin typeface="Aptos"/>
                <a:ea typeface="DejaVu Sans"/>
              </a:rPr>
              <a:t>. 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41" name="Picture 40"/>
          <p:cNvPicPr/>
          <p:nvPr/>
        </p:nvPicPr>
        <p:blipFill>
          <a:blip r:embed="rId2"/>
          <a:stretch/>
        </p:blipFill>
        <p:spPr>
          <a:xfrm>
            <a:off x="2194560" y="130680"/>
            <a:ext cx="6775200" cy="508104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28D7DE2-E3D4-F3C7-694A-C6DA3998EE0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CustomShape 1">
            <a:extLst>
              <a:ext uri="{FF2B5EF4-FFF2-40B4-BE49-F238E27FC236}">
                <a16:creationId xmlns:a16="http://schemas.microsoft.com/office/drawing/2014/main" id="{967E3B2A-094E-06DD-E9C2-330C0FE5080F}"/>
              </a:ext>
            </a:extLst>
          </p:cNvPr>
          <p:cNvSpPr/>
          <p:nvPr/>
        </p:nvSpPr>
        <p:spPr>
          <a:xfrm>
            <a:off x="800100" y="5744803"/>
            <a:ext cx="11201399" cy="644877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Supplemental Figure S6. </a:t>
            </a:r>
            <a:r>
              <a:rPr lang="en-US" sz="1800" strike="noStrike" spc="-1" dirty="0">
                <a:solidFill>
                  <a:srgbClr val="000000"/>
                </a:solidFill>
                <a:latin typeface="Arial"/>
                <a:ea typeface="DejaVu Sans"/>
              </a:rPr>
              <a:t>326 thyroid </a:t>
            </a:r>
            <a:r>
              <a:rPr lang="en-US" spc="-1" dirty="0">
                <a:solidFill>
                  <a:srgbClr val="000000"/>
                </a:solidFill>
                <a:latin typeface="Arial"/>
                <a:ea typeface="DejaVu Sans"/>
              </a:rPr>
              <a:t>“core gene” PPI network is shown</a:t>
            </a:r>
            <a:r>
              <a:rPr lang="en-US" sz="1800" strike="noStrike" spc="-1" dirty="0">
                <a:solidFill>
                  <a:srgbClr val="000000"/>
                </a:solidFill>
                <a:latin typeface="Aptos"/>
                <a:ea typeface="DejaVu Sans"/>
              </a:rPr>
              <a:t>. Topology metrics are also shown along with the degree distribution.   </a:t>
            </a:r>
            <a:endParaRPr lang="en-US" sz="1800" strike="noStrike" spc="-1" dirty="0">
              <a:latin typeface="Arial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F56F1F8-B727-219F-1304-DD3F060A1C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22" r="24377"/>
          <a:stretch/>
        </p:blipFill>
        <p:spPr>
          <a:xfrm>
            <a:off x="1123951" y="353653"/>
            <a:ext cx="5943600" cy="53911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BEBAA8D-606A-4CCE-AFFB-16A4A24A4E08}"/>
              </a:ext>
            </a:extLst>
          </p:cNvPr>
          <p:cNvSpPr txBox="1"/>
          <p:nvPr/>
        </p:nvSpPr>
        <p:spPr>
          <a:xfrm>
            <a:off x="7419053" y="1041343"/>
            <a:ext cx="4220497" cy="36933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u="sng" dirty="0"/>
              <a:t>Topology Statistics  </a:t>
            </a:r>
          </a:p>
          <a:p>
            <a:r>
              <a:rPr lang="en-US" dirty="0"/>
              <a:t>Number of nodes: 279  </a:t>
            </a:r>
          </a:p>
          <a:p>
            <a:r>
              <a:rPr lang="en-US" dirty="0"/>
              <a:t>Number of edges: 1549  </a:t>
            </a:r>
          </a:p>
          <a:p>
            <a:r>
              <a:rPr lang="en-US" dirty="0"/>
              <a:t>Avg. number of neighbors:    3.115  </a:t>
            </a:r>
          </a:p>
          <a:p>
            <a:r>
              <a:rPr lang="en-US" dirty="0"/>
              <a:t>Network diameter:  11  </a:t>
            </a:r>
          </a:p>
          <a:p>
            <a:r>
              <a:rPr lang="en-US" dirty="0"/>
              <a:t>Network radius:   6  </a:t>
            </a:r>
          </a:p>
          <a:p>
            <a:r>
              <a:rPr lang="en-US" dirty="0"/>
              <a:t>Characteristic path length:    4.312  </a:t>
            </a:r>
          </a:p>
          <a:p>
            <a:r>
              <a:rPr lang="en-US" dirty="0"/>
              <a:t>Clustering coefficient:    0.108  </a:t>
            </a:r>
          </a:p>
          <a:p>
            <a:r>
              <a:rPr lang="en-US" dirty="0"/>
              <a:t>Network density:    0.014  </a:t>
            </a:r>
          </a:p>
          <a:p>
            <a:r>
              <a:rPr lang="en-US" dirty="0"/>
              <a:t>Network heterogeneity:    1.111  </a:t>
            </a:r>
          </a:p>
          <a:p>
            <a:r>
              <a:rPr lang="en-US" dirty="0"/>
              <a:t>Network centralization:    0.112  </a:t>
            </a:r>
          </a:p>
          <a:p>
            <a:r>
              <a:rPr lang="en-US" dirty="0"/>
              <a:t>Connected components:  43  </a:t>
            </a:r>
          </a:p>
          <a:p>
            <a:r>
              <a:rPr lang="en-US" dirty="0"/>
              <a:t>Analysis time (sec):    0.056 </a:t>
            </a:r>
          </a:p>
        </p:txBody>
      </p:sp>
    </p:spTree>
    <p:extLst>
      <p:ext uri="{BB962C8B-B14F-4D97-AF65-F5344CB8AC3E}">
        <p14:creationId xmlns:p14="http://schemas.microsoft.com/office/powerpoint/2010/main" val="3877186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</TotalTime>
  <Words>225</Words>
  <Application>Microsoft Office PowerPoint</Application>
  <PresentationFormat>Widescreen</PresentationFormat>
  <Paragraphs>1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rial</vt:lpstr>
      <vt:lpstr>Symbol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lex Feltus</dc:creator>
  <dc:description/>
  <cp:lastModifiedBy>Alex Feltus</cp:lastModifiedBy>
  <cp:revision>7</cp:revision>
  <dcterms:created xsi:type="dcterms:W3CDTF">2024-09-25T20:57:01Z</dcterms:created>
  <dcterms:modified xsi:type="dcterms:W3CDTF">2025-01-17T20:20:30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Widescreen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1</vt:i4>
  </property>
</Properties>
</file>